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4D384-9CF7-46AD-9272-A05D846642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DB6DE-03B7-4942-9BC7-4734A63CC0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B7BFD-C6A2-4D2E-88E8-9D62B0F59C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ED755-3495-42A7-9DA3-47CE3582A3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1E03C-FDF0-4D5D-A04B-5D572AD1C6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16FF9-D5AC-41F4-9B67-3C7ACD45DA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0F1F5-CBB5-4FFC-B0E6-6875737404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B4276-4484-4A2F-A01F-BD61F8E733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05C16-01A1-4A3E-BDF7-BD448124D4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883E26-9310-4BEB-BD0F-6BB95BC20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7513E-0ACB-467C-940C-75C792D2F1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FFA40-AF7F-4682-A9E1-A08C168C3A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93D961-AF15-4ECA-8B69-E8AE647785F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828800" y="380880"/>
            <a:ext cx="5648400" cy="4525920"/>
          </a:xfrm>
          <a:prstGeom prst="rect">
            <a:avLst/>
          </a:prstGeom>
          <a:ln w="0">
            <a:noFill/>
          </a:ln>
        </p:spPr>
      </p:pic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7200" y="54860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Correlation of log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ransformed urinary arsenic creatinine ratio (UACR) and log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ransformed well water arsenic (WAs) concentration (r=0.66, p=3.7 E-280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3T22:36:52Z</dcterms:created>
  <dc:creator>mkibriya</dc:creator>
  <dc:description/>
  <dc:language>en-US</dc:language>
  <cp:lastModifiedBy>mkibriya</cp:lastModifiedBy>
  <dcterms:modified xsi:type="dcterms:W3CDTF">2017-03-29T18:43:57Z</dcterms:modified>
  <cp:revision>33</cp:revision>
  <dc:subject/>
  <dc:title>Slide 1</dc:title>
</cp:coreProperties>
</file>